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45" y="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1AC649-642C-496D-BC3E-A6AA8E4339E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868E1C-A404-422C-BAD8-765B30040BC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3520D5-3E33-4496-BF5F-454D2A2E85F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7F2C8-CEC6-4783-9747-EBF77380BB32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58E73-1BDB-47F7-AEE0-F328BD3032F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26"/>
          <p:cNvGrpSpPr/>
          <p:nvPr/>
        </p:nvGrpSpPr>
        <p:grpSpPr>
          <a:xfrm>
            <a:off x="152400" y="457200"/>
            <a:ext cx="8610600" cy="6324600"/>
            <a:chOff x="0" y="152400"/>
            <a:chExt cx="9144000" cy="7315200"/>
          </a:xfrm>
        </p:grpSpPr>
        <p:sp>
          <p:nvSpPr>
            <p:cNvPr id="126" name="Rectangle 125"/>
            <p:cNvSpPr/>
            <p:nvPr/>
          </p:nvSpPr>
          <p:spPr>
            <a:xfrm>
              <a:off x="0" y="6858000"/>
              <a:ext cx="9144000" cy="609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Freeform 8"/>
            <p:cNvSpPr>
              <a:spLocks noEditPoints="1"/>
            </p:cNvSpPr>
            <p:nvPr/>
          </p:nvSpPr>
          <p:spPr bwMode="auto">
            <a:xfrm>
              <a:off x="1138449" y="478923"/>
              <a:ext cx="7774696" cy="1656979"/>
            </a:xfrm>
            <a:custGeom>
              <a:avLst/>
              <a:gdLst>
                <a:gd name="T0" fmla="*/ 0 w 10347"/>
                <a:gd name="T1" fmla="*/ 1719 h 1725"/>
                <a:gd name="T2" fmla="*/ 10347 w 10347"/>
                <a:gd name="T3" fmla="*/ 1719 h 1725"/>
                <a:gd name="T4" fmla="*/ 10347 w 10347"/>
                <a:gd name="T5" fmla="*/ 1725 h 1725"/>
                <a:gd name="T6" fmla="*/ 0 w 10347"/>
                <a:gd name="T7" fmla="*/ 1725 h 1725"/>
                <a:gd name="T8" fmla="*/ 0 w 10347"/>
                <a:gd name="T9" fmla="*/ 1719 h 1725"/>
                <a:gd name="T10" fmla="*/ 0 w 10347"/>
                <a:gd name="T11" fmla="*/ 1289 h 1725"/>
                <a:gd name="T12" fmla="*/ 10347 w 10347"/>
                <a:gd name="T13" fmla="*/ 1289 h 1725"/>
                <a:gd name="T14" fmla="*/ 10347 w 10347"/>
                <a:gd name="T15" fmla="*/ 1295 h 1725"/>
                <a:gd name="T16" fmla="*/ 0 w 10347"/>
                <a:gd name="T17" fmla="*/ 1295 h 1725"/>
                <a:gd name="T18" fmla="*/ 0 w 10347"/>
                <a:gd name="T19" fmla="*/ 1289 h 1725"/>
                <a:gd name="T20" fmla="*/ 0 w 10347"/>
                <a:gd name="T21" fmla="*/ 859 h 1725"/>
                <a:gd name="T22" fmla="*/ 10347 w 10347"/>
                <a:gd name="T23" fmla="*/ 859 h 1725"/>
                <a:gd name="T24" fmla="*/ 10347 w 10347"/>
                <a:gd name="T25" fmla="*/ 865 h 1725"/>
                <a:gd name="T26" fmla="*/ 0 w 10347"/>
                <a:gd name="T27" fmla="*/ 865 h 1725"/>
                <a:gd name="T28" fmla="*/ 0 w 10347"/>
                <a:gd name="T29" fmla="*/ 859 h 1725"/>
                <a:gd name="T30" fmla="*/ 0 w 10347"/>
                <a:gd name="T31" fmla="*/ 429 h 1725"/>
                <a:gd name="T32" fmla="*/ 10347 w 10347"/>
                <a:gd name="T33" fmla="*/ 429 h 1725"/>
                <a:gd name="T34" fmla="*/ 10347 w 10347"/>
                <a:gd name="T35" fmla="*/ 435 h 1725"/>
                <a:gd name="T36" fmla="*/ 0 w 10347"/>
                <a:gd name="T37" fmla="*/ 435 h 1725"/>
                <a:gd name="T38" fmla="*/ 0 w 10347"/>
                <a:gd name="T39" fmla="*/ 429 h 1725"/>
                <a:gd name="T40" fmla="*/ 0 w 10347"/>
                <a:gd name="T41" fmla="*/ 0 h 1725"/>
                <a:gd name="T42" fmla="*/ 10347 w 10347"/>
                <a:gd name="T43" fmla="*/ 0 h 1725"/>
                <a:gd name="T44" fmla="*/ 10347 w 10347"/>
                <a:gd name="T45" fmla="*/ 6 h 1725"/>
                <a:gd name="T46" fmla="*/ 0 w 10347"/>
                <a:gd name="T47" fmla="*/ 6 h 1725"/>
                <a:gd name="T48" fmla="*/ 0 w 10347"/>
                <a:gd name="T49" fmla="*/ 0 h 17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0347" h="1725">
                  <a:moveTo>
                    <a:pt x="0" y="1719"/>
                  </a:moveTo>
                  <a:lnTo>
                    <a:pt x="10347" y="1719"/>
                  </a:lnTo>
                  <a:lnTo>
                    <a:pt x="10347" y="1725"/>
                  </a:lnTo>
                  <a:lnTo>
                    <a:pt x="0" y="1725"/>
                  </a:lnTo>
                  <a:lnTo>
                    <a:pt x="0" y="1719"/>
                  </a:lnTo>
                  <a:close/>
                  <a:moveTo>
                    <a:pt x="0" y="1289"/>
                  </a:moveTo>
                  <a:lnTo>
                    <a:pt x="10347" y="1289"/>
                  </a:lnTo>
                  <a:lnTo>
                    <a:pt x="10347" y="1295"/>
                  </a:lnTo>
                  <a:lnTo>
                    <a:pt x="0" y="1295"/>
                  </a:lnTo>
                  <a:lnTo>
                    <a:pt x="0" y="1289"/>
                  </a:lnTo>
                  <a:close/>
                  <a:moveTo>
                    <a:pt x="0" y="859"/>
                  </a:moveTo>
                  <a:lnTo>
                    <a:pt x="10347" y="859"/>
                  </a:lnTo>
                  <a:lnTo>
                    <a:pt x="10347" y="865"/>
                  </a:lnTo>
                  <a:lnTo>
                    <a:pt x="0" y="865"/>
                  </a:lnTo>
                  <a:lnTo>
                    <a:pt x="0" y="859"/>
                  </a:lnTo>
                  <a:close/>
                  <a:moveTo>
                    <a:pt x="0" y="429"/>
                  </a:moveTo>
                  <a:lnTo>
                    <a:pt x="10347" y="429"/>
                  </a:lnTo>
                  <a:lnTo>
                    <a:pt x="10347" y="435"/>
                  </a:lnTo>
                  <a:lnTo>
                    <a:pt x="0" y="435"/>
                  </a:lnTo>
                  <a:lnTo>
                    <a:pt x="0" y="429"/>
                  </a:lnTo>
                  <a:close/>
                  <a:moveTo>
                    <a:pt x="0" y="0"/>
                  </a:moveTo>
                  <a:lnTo>
                    <a:pt x="10347" y="0"/>
                  </a:lnTo>
                  <a:lnTo>
                    <a:pt x="1034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Freeform 9"/>
            <p:cNvSpPr>
              <a:spLocks noEditPoints="1"/>
            </p:cNvSpPr>
            <p:nvPr/>
          </p:nvSpPr>
          <p:spPr bwMode="auto">
            <a:xfrm>
              <a:off x="1218849" y="770935"/>
              <a:ext cx="7614649" cy="1775128"/>
            </a:xfrm>
            <a:custGeom>
              <a:avLst/>
              <a:gdLst>
                <a:gd name="T0" fmla="*/ 143 w 10134"/>
                <a:gd name="T1" fmla="*/ 1848 h 1848"/>
                <a:gd name="T2" fmla="*/ 357 w 10134"/>
                <a:gd name="T3" fmla="*/ 1783 h 1848"/>
                <a:gd name="T4" fmla="*/ 357 w 10134"/>
                <a:gd name="T5" fmla="*/ 1848 h 1848"/>
                <a:gd name="T6" fmla="*/ 856 w 10134"/>
                <a:gd name="T7" fmla="*/ 1772 h 1848"/>
                <a:gd name="T8" fmla="*/ 714 w 10134"/>
                <a:gd name="T9" fmla="*/ 1772 h 1848"/>
                <a:gd name="T10" fmla="*/ 1213 w 10134"/>
                <a:gd name="T11" fmla="*/ 1848 h 1848"/>
                <a:gd name="T12" fmla="*/ 1427 w 10134"/>
                <a:gd name="T13" fmla="*/ 1678 h 1848"/>
                <a:gd name="T14" fmla="*/ 1427 w 10134"/>
                <a:gd name="T15" fmla="*/ 1848 h 1848"/>
                <a:gd name="T16" fmla="*/ 1927 w 10134"/>
                <a:gd name="T17" fmla="*/ 1785 h 1848"/>
                <a:gd name="T18" fmla="*/ 1785 w 10134"/>
                <a:gd name="T19" fmla="*/ 1785 h 1848"/>
                <a:gd name="T20" fmla="*/ 2284 w 10134"/>
                <a:gd name="T21" fmla="*/ 1848 h 1848"/>
                <a:gd name="T22" fmla="*/ 2498 w 10134"/>
                <a:gd name="T23" fmla="*/ 1764 h 1848"/>
                <a:gd name="T24" fmla="*/ 2498 w 10134"/>
                <a:gd name="T25" fmla="*/ 1848 h 1848"/>
                <a:gd name="T26" fmla="*/ 2997 w 10134"/>
                <a:gd name="T27" fmla="*/ 1817 h 1848"/>
                <a:gd name="T28" fmla="*/ 2855 w 10134"/>
                <a:gd name="T29" fmla="*/ 1817 h 1848"/>
                <a:gd name="T30" fmla="*/ 3354 w 10134"/>
                <a:gd name="T31" fmla="*/ 1848 h 1848"/>
                <a:gd name="T32" fmla="*/ 3568 w 10134"/>
                <a:gd name="T33" fmla="*/ 1702 h 1848"/>
                <a:gd name="T34" fmla="*/ 3568 w 10134"/>
                <a:gd name="T35" fmla="*/ 1848 h 1848"/>
                <a:gd name="T36" fmla="*/ 4067 w 10134"/>
                <a:gd name="T37" fmla="*/ 1761 h 1848"/>
                <a:gd name="T38" fmla="*/ 3925 w 10134"/>
                <a:gd name="T39" fmla="*/ 1761 h 1848"/>
                <a:gd name="T40" fmla="*/ 4425 w 10134"/>
                <a:gd name="T41" fmla="*/ 1848 h 1848"/>
                <a:gd name="T42" fmla="*/ 4639 w 10134"/>
                <a:gd name="T43" fmla="*/ 1695 h 1848"/>
                <a:gd name="T44" fmla="*/ 4639 w 10134"/>
                <a:gd name="T45" fmla="*/ 1848 h 1848"/>
                <a:gd name="T46" fmla="*/ 5138 w 10134"/>
                <a:gd name="T47" fmla="*/ 1691 h 1848"/>
                <a:gd name="T48" fmla="*/ 4996 w 10134"/>
                <a:gd name="T49" fmla="*/ 1691 h 1848"/>
                <a:gd name="T50" fmla="*/ 5495 w 10134"/>
                <a:gd name="T51" fmla="*/ 1848 h 1848"/>
                <a:gd name="T52" fmla="*/ 5709 w 10134"/>
                <a:gd name="T53" fmla="*/ 1796 h 1848"/>
                <a:gd name="T54" fmla="*/ 5709 w 10134"/>
                <a:gd name="T55" fmla="*/ 1848 h 1848"/>
                <a:gd name="T56" fmla="*/ 6208 w 10134"/>
                <a:gd name="T57" fmla="*/ 1720 h 1848"/>
                <a:gd name="T58" fmla="*/ 6066 w 10134"/>
                <a:gd name="T59" fmla="*/ 1720 h 1848"/>
                <a:gd name="T60" fmla="*/ 6565 w 10134"/>
                <a:gd name="T61" fmla="*/ 1848 h 1848"/>
                <a:gd name="T62" fmla="*/ 6779 w 10134"/>
                <a:gd name="T63" fmla="*/ 1739 h 1848"/>
                <a:gd name="T64" fmla="*/ 6779 w 10134"/>
                <a:gd name="T65" fmla="*/ 1848 h 1848"/>
                <a:gd name="T66" fmla="*/ 7279 w 10134"/>
                <a:gd name="T67" fmla="*/ 1782 h 1848"/>
                <a:gd name="T68" fmla="*/ 7137 w 10134"/>
                <a:gd name="T69" fmla="*/ 1782 h 1848"/>
                <a:gd name="T70" fmla="*/ 7636 w 10134"/>
                <a:gd name="T71" fmla="*/ 1848 h 1848"/>
                <a:gd name="T72" fmla="*/ 7850 w 10134"/>
                <a:gd name="T73" fmla="*/ 1787 h 1848"/>
                <a:gd name="T74" fmla="*/ 7850 w 10134"/>
                <a:gd name="T75" fmla="*/ 1848 h 1848"/>
                <a:gd name="T76" fmla="*/ 8349 w 10134"/>
                <a:gd name="T77" fmla="*/ 1794 h 1848"/>
                <a:gd name="T78" fmla="*/ 8207 w 10134"/>
                <a:gd name="T79" fmla="*/ 1794 h 1848"/>
                <a:gd name="T80" fmla="*/ 8706 w 10134"/>
                <a:gd name="T81" fmla="*/ 1848 h 1848"/>
                <a:gd name="T82" fmla="*/ 8920 w 10134"/>
                <a:gd name="T83" fmla="*/ 1781 h 1848"/>
                <a:gd name="T84" fmla="*/ 8920 w 10134"/>
                <a:gd name="T85" fmla="*/ 1848 h 1848"/>
                <a:gd name="T86" fmla="*/ 9419 w 10134"/>
                <a:gd name="T87" fmla="*/ 1790 h 1848"/>
                <a:gd name="T88" fmla="*/ 9277 w 10134"/>
                <a:gd name="T89" fmla="*/ 1790 h 1848"/>
                <a:gd name="T90" fmla="*/ 9777 w 10134"/>
                <a:gd name="T91" fmla="*/ 1848 h 1848"/>
                <a:gd name="T92" fmla="*/ 9991 w 10134"/>
                <a:gd name="T93" fmla="*/ 1789 h 1848"/>
                <a:gd name="T94" fmla="*/ 9991 w 10134"/>
                <a:gd name="T95" fmla="*/ 1848 h 18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10134" h="1848">
                  <a:moveTo>
                    <a:pt x="0" y="1795"/>
                  </a:moveTo>
                  <a:lnTo>
                    <a:pt x="143" y="1795"/>
                  </a:lnTo>
                  <a:lnTo>
                    <a:pt x="143" y="1848"/>
                  </a:lnTo>
                  <a:lnTo>
                    <a:pt x="0" y="1848"/>
                  </a:lnTo>
                  <a:lnTo>
                    <a:pt x="0" y="1795"/>
                  </a:lnTo>
                  <a:close/>
                  <a:moveTo>
                    <a:pt x="357" y="1783"/>
                  </a:moveTo>
                  <a:lnTo>
                    <a:pt x="500" y="1783"/>
                  </a:lnTo>
                  <a:lnTo>
                    <a:pt x="500" y="1848"/>
                  </a:lnTo>
                  <a:lnTo>
                    <a:pt x="357" y="1848"/>
                  </a:lnTo>
                  <a:lnTo>
                    <a:pt x="357" y="1783"/>
                  </a:lnTo>
                  <a:close/>
                  <a:moveTo>
                    <a:pt x="714" y="1772"/>
                  </a:moveTo>
                  <a:lnTo>
                    <a:pt x="856" y="1772"/>
                  </a:lnTo>
                  <a:lnTo>
                    <a:pt x="856" y="1848"/>
                  </a:lnTo>
                  <a:lnTo>
                    <a:pt x="714" y="1848"/>
                  </a:lnTo>
                  <a:lnTo>
                    <a:pt x="714" y="1772"/>
                  </a:lnTo>
                  <a:close/>
                  <a:moveTo>
                    <a:pt x="1070" y="1750"/>
                  </a:moveTo>
                  <a:lnTo>
                    <a:pt x="1213" y="1750"/>
                  </a:lnTo>
                  <a:lnTo>
                    <a:pt x="1213" y="1848"/>
                  </a:lnTo>
                  <a:lnTo>
                    <a:pt x="1070" y="1848"/>
                  </a:lnTo>
                  <a:lnTo>
                    <a:pt x="1070" y="1750"/>
                  </a:lnTo>
                  <a:close/>
                  <a:moveTo>
                    <a:pt x="1427" y="1678"/>
                  </a:moveTo>
                  <a:lnTo>
                    <a:pt x="1570" y="1678"/>
                  </a:lnTo>
                  <a:lnTo>
                    <a:pt x="1570" y="1848"/>
                  </a:lnTo>
                  <a:lnTo>
                    <a:pt x="1427" y="1848"/>
                  </a:lnTo>
                  <a:lnTo>
                    <a:pt x="1427" y="1678"/>
                  </a:lnTo>
                  <a:close/>
                  <a:moveTo>
                    <a:pt x="1785" y="1785"/>
                  </a:moveTo>
                  <a:lnTo>
                    <a:pt x="1927" y="1785"/>
                  </a:lnTo>
                  <a:lnTo>
                    <a:pt x="1927" y="1848"/>
                  </a:lnTo>
                  <a:lnTo>
                    <a:pt x="1785" y="1848"/>
                  </a:lnTo>
                  <a:lnTo>
                    <a:pt x="1785" y="1785"/>
                  </a:lnTo>
                  <a:close/>
                  <a:moveTo>
                    <a:pt x="2141" y="1795"/>
                  </a:moveTo>
                  <a:lnTo>
                    <a:pt x="2284" y="1795"/>
                  </a:lnTo>
                  <a:lnTo>
                    <a:pt x="2284" y="1848"/>
                  </a:lnTo>
                  <a:lnTo>
                    <a:pt x="2141" y="1848"/>
                  </a:lnTo>
                  <a:lnTo>
                    <a:pt x="2141" y="1795"/>
                  </a:lnTo>
                  <a:close/>
                  <a:moveTo>
                    <a:pt x="2498" y="1764"/>
                  </a:moveTo>
                  <a:lnTo>
                    <a:pt x="2641" y="1764"/>
                  </a:lnTo>
                  <a:lnTo>
                    <a:pt x="2641" y="1848"/>
                  </a:lnTo>
                  <a:lnTo>
                    <a:pt x="2498" y="1848"/>
                  </a:lnTo>
                  <a:lnTo>
                    <a:pt x="2498" y="1764"/>
                  </a:lnTo>
                  <a:close/>
                  <a:moveTo>
                    <a:pt x="2855" y="1817"/>
                  </a:moveTo>
                  <a:lnTo>
                    <a:pt x="2997" y="1817"/>
                  </a:lnTo>
                  <a:lnTo>
                    <a:pt x="2997" y="1848"/>
                  </a:lnTo>
                  <a:lnTo>
                    <a:pt x="2855" y="1848"/>
                  </a:lnTo>
                  <a:lnTo>
                    <a:pt x="2855" y="1817"/>
                  </a:lnTo>
                  <a:close/>
                  <a:moveTo>
                    <a:pt x="3211" y="0"/>
                  </a:moveTo>
                  <a:lnTo>
                    <a:pt x="3354" y="0"/>
                  </a:lnTo>
                  <a:lnTo>
                    <a:pt x="3354" y="1848"/>
                  </a:lnTo>
                  <a:lnTo>
                    <a:pt x="3211" y="1848"/>
                  </a:lnTo>
                  <a:lnTo>
                    <a:pt x="3211" y="0"/>
                  </a:lnTo>
                  <a:close/>
                  <a:moveTo>
                    <a:pt x="3568" y="1702"/>
                  </a:moveTo>
                  <a:lnTo>
                    <a:pt x="3711" y="1702"/>
                  </a:lnTo>
                  <a:lnTo>
                    <a:pt x="3711" y="1848"/>
                  </a:lnTo>
                  <a:lnTo>
                    <a:pt x="3568" y="1848"/>
                  </a:lnTo>
                  <a:lnTo>
                    <a:pt x="3568" y="1702"/>
                  </a:lnTo>
                  <a:close/>
                  <a:moveTo>
                    <a:pt x="3925" y="1761"/>
                  </a:moveTo>
                  <a:lnTo>
                    <a:pt x="4067" y="1761"/>
                  </a:lnTo>
                  <a:lnTo>
                    <a:pt x="4067" y="1848"/>
                  </a:lnTo>
                  <a:lnTo>
                    <a:pt x="3925" y="1848"/>
                  </a:lnTo>
                  <a:lnTo>
                    <a:pt x="3925" y="1761"/>
                  </a:lnTo>
                  <a:close/>
                  <a:moveTo>
                    <a:pt x="4281" y="1784"/>
                  </a:moveTo>
                  <a:lnTo>
                    <a:pt x="4425" y="1784"/>
                  </a:lnTo>
                  <a:lnTo>
                    <a:pt x="4425" y="1848"/>
                  </a:lnTo>
                  <a:lnTo>
                    <a:pt x="4281" y="1848"/>
                  </a:lnTo>
                  <a:lnTo>
                    <a:pt x="4281" y="1784"/>
                  </a:lnTo>
                  <a:close/>
                  <a:moveTo>
                    <a:pt x="4639" y="1695"/>
                  </a:moveTo>
                  <a:lnTo>
                    <a:pt x="4782" y="1695"/>
                  </a:lnTo>
                  <a:lnTo>
                    <a:pt x="4782" y="1848"/>
                  </a:lnTo>
                  <a:lnTo>
                    <a:pt x="4639" y="1848"/>
                  </a:lnTo>
                  <a:lnTo>
                    <a:pt x="4639" y="1695"/>
                  </a:lnTo>
                  <a:close/>
                  <a:moveTo>
                    <a:pt x="4996" y="1691"/>
                  </a:moveTo>
                  <a:lnTo>
                    <a:pt x="5138" y="1691"/>
                  </a:lnTo>
                  <a:lnTo>
                    <a:pt x="5138" y="1848"/>
                  </a:lnTo>
                  <a:lnTo>
                    <a:pt x="4996" y="1848"/>
                  </a:lnTo>
                  <a:lnTo>
                    <a:pt x="4996" y="1691"/>
                  </a:lnTo>
                  <a:close/>
                  <a:moveTo>
                    <a:pt x="5352" y="1791"/>
                  </a:moveTo>
                  <a:lnTo>
                    <a:pt x="5495" y="1791"/>
                  </a:lnTo>
                  <a:lnTo>
                    <a:pt x="5495" y="1848"/>
                  </a:lnTo>
                  <a:lnTo>
                    <a:pt x="5352" y="1848"/>
                  </a:lnTo>
                  <a:lnTo>
                    <a:pt x="5352" y="1791"/>
                  </a:lnTo>
                  <a:close/>
                  <a:moveTo>
                    <a:pt x="5709" y="1796"/>
                  </a:moveTo>
                  <a:lnTo>
                    <a:pt x="5852" y="1796"/>
                  </a:lnTo>
                  <a:lnTo>
                    <a:pt x="5852" y="1848"/>
                  </a:lnTo>
                  <a:lnTo>
                    <a:pt x="5709" y="1848"/>
                  </a:lnTo>
                  <a:lnTo>
                    <a:pt x="5709" y="1796"/>
                  </a:lnTo>
                  <a:close/>
                  <a:moveTo>
                    <a:pt x="6066" y="1720"/>
                  </a:moveTo>
                  <a:lnTo>
                    <a:pt x="6208" y="1720"/>
                  </a:lnTo>
                  <a:lnTo>
                    <a:pt x="6208" y="1848"/>
                  </a:lnTo>
                  <a:lnTo>
                    <a:pt x="6066" y="1848"/>
                  </a:lnTo>
                  <a:lnTo>
                    <a:pt x="6066" y="1720"/>
                  </a:lnTo>
                  <a:close/>
                  <a:moveTo>
                    <a:pt x="6422" y="1756"/>
                  </a:moveTo>
                  <a:lnTo>
                    <a:pt x="6565" y="1756"/>
                  </a:lnTo>
                  <a:lnTo>
                    <a:pt x="6565" y="1848"/>
                  </a:lnTo>
                  <a:lnTo>
                    <a:pt x="6422" y="1848"/>
                  </a:lnTo>
                  <a:lnTo>
                    <a:pt x="6422" y="1756"/>
                  </a:lnTo>
                  <a:close/>
                  <a:moveTo>
                    <a:pt x="6779" y="1739"/>
                  </a:moveTo>
                  <a:lnTo>
                    <a:pt x="6922" y="1739"/>
                  </a:lnTo>
                  <a:lnTo>
                    <a:pt x="6922" y="1848"/>
                  </a:lnTo>
                  <a:lnTo>
                    <a:pt x="6779" y="1848"/>
                  </a:lnTo>
                  <a:lnTo>
                    <a:pt x="6779" y="1739"/>
                  </a:lnTo>
                  <a:close/>
                  <a:moveTo>
                    <a:pt x="7137" y="1782"/>
                  </a:moveTo>
                  <a:lnTo>
                    <a:pt x="7279" y="1782"/>
                  </a:lnTo>
                  <a:lnTo>
                    <a:pt x="7279" y="1848"/>
                  </a:lnTo>
                  <a:lnTo>
                    <a:pt x="7137" y="1848"/>
                  </a:lnTo>
                  <a:lnTo>
                    <a:pt x="7137" y="1782"/>
                  </a:lnTo>
                  <a:close/>
                  <a:moveTo>
                    <a:pt x="7493" y="1799"/>
                  </a:moveTo>
                  <a:lnTo>
                    <a:pt x="7636" y="1799"/>
                  </a:lnTo>
                  <a:lnTo>
                    <a:pt x="7636" y="1848"/>
                  </a:lnTo>
                  <a:lnTo>
                    <a:pt x="7493" y="1848"/>
                  </a:lnTo>
                  <a:lnTo>
                    <a:pt x="7493" y="1799"/>
                  </a:lnTo>
                  <a:close/>
                  <a:moveTo>
                    <a:pt x="7850" y="1787"/>
                  </a:moveTo>
                  <a:lnTo>
                    <a:pt x="7993" y="1787"/>
                  </a:lnTo>
                  <a:lnTo>
                    <a:pt x="7993" y="1848"/>
                  </a:lnTo>
                  <a:lnTo>
                    <a:pt x="7850" y="1848"/>
                  </a:lnTo>
                  <a:lnTo>
                    <a:pt x="7850" y="1787"/>
                  </a:lnTo>
                  <a:close/>
                  <a:moveTo>
                    <a:pt x="8207" y="1794"/>
                  </a:moveTo>
                  <a:lnTo>
                    <a:pt x="8349" y="1794"/>
                  </a:lnTo>
                  <a:lnTo>
                    <a:pt x="8349" y="1848"/>
                  </a:lnTo>
                  <a:lnTo>
                    <a:pt x="8207" y="1848"/>
                  </a:lnTo>
                  <a:lnTo>
                    <a:pt x="8207" y="1794"/>
                  </a:lnTo>
                  <a:close/>
                  <a:moveTo>
                    <a:pt x="8563" y="1799"/>
                  </a:moveTo>
                  <a:lnTo>
                    <a:pt x="8706" y="1799"/>
                  </a:lnTo>
                  <a:lnTo>
                    <a:pt x="8706" y="1848"/>
                  </a:lnTo>
                  <a:lnTo>
                    <a:pt x="8563" y="1848"/>
                  </a:lnTo>
                  <a:lnTo>
                    <a:pt x="8563" y="1799"/>
                  </a:lnTo>
                  <a:close/>
                  <a:moveTo>
                    <a:pt x="8920" y="1781"/>
                  </a:moveTo>
                  <a:lnTo>
                    <a:pt x="9063" y="1781"/>
                  </a:lnTo>
                  <a:lnTo>
                    <a:pt x="9063" y="1848"/>
                  </a:lnTo>
                  <a:lnTo>
                    <a:pt x="8920" y="1848"/>
                  </a:lnTo>
                  <a:lnTo>
                    <a:pt x="8920" y="1781"/>
                  </a:lnTo>
                  <a:close/>
                  <a:moveTo>
                    <a:pt x="9277" y="1790"/>
                  </a:moveTo>
                  <a:lnTo>
                    <a:pt x="9419" y="1790"/>
                  </a:lnTo>
                  <a:lnTo>
                    <a:pt x="9419" y="1848"/>
                  </a:lnTo>
                  <a:lnTo>
                    <a:pt x="9277" y="1848"/>
                  </a:lnTo>
                  <a:lnTo>
                    <a:pt x="9277" y="1790"/>
                  </a:lnTo>
                  <a:close/>
                  <a:moveTo>
                    <a:pt x="9633" y="1790"/>
                  </a:moveTo>
                  <a:lnTo>
                    <a:pt x="9777" y="1790"/>
                  </a:lnTo>
                  <a:lnTo>
                    <a:pt x="9777" y="1848"/>
                  </a:lnTo>
                  <a:lnTo>
                    <a:pt x="9633" y="1848"/>
                  </a:lnTo>
                  <a:lnTo>
                    <a:pt x="9633" y="1790"/>
                  </a:lnTo>
                  <a:close/>
                  <a:moveTo>
                    <a:pt x="9991" y="1789"/>
                  </a:moveTo>
                  <a:lnTo>
                    <a:pt x="10134" y="1789"/>
                  </a:lnTo>
                  <a:lnTo>
                    <a:pt x="10134" y="1848"/>
                  </a:lnTo>
                  <a:lnTo>
                    <a:pt x="9991" y="1848"/>
                  </a:lnTo>
                  <a:lnTo>
                    <a:pt x="9991" y="1789"/>
                  </a:lnTo>
                  <a:close/>
                </a:path>
              </a:pathLst>
            </a:custGeom>
            <a:solidFill>
              <a:srgbClr val="C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Rectangle 10"/>
            <p:cNvSpPr>
              <a:spLocks noChangeArrowheads="1"/>
            </p:cNvSpPr>
            <p:nvPr/>
          </p:nvSpPr>
          <p:spPr bwMode="auto">
            <a:xfrm>
              <a:off x="1136195" y="481804"/>
              <a:ext cx="4508" cy="2064260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Freeform 11"/>
            <p:cNvSpPr>
              <a:spLocks noEditPoints="1"/>
            </p:cNvSpPr>
            <p:nvPr/>
          </p:nvSpPr>
          <p:spPr bwMode="auto">
            <a:xfrm>
              <a:off x="1109145" y="478923"/>
              <a:ext cx="29305" cy="2070023"/>
            </a:xfrm>
            <a:custGeom>
              <a:avLst/>
              <a:gdLst>
                <a:gd name="T0" fmla="*/ 0 w 39"/>
                <a:gd name="T1" fmla="*/ 2149 h 2155"/>
                <a:gd name="T2" fmla="*/ 39 w 39"/>
                <a:gd name="T3" fmla="*/ 2149 h 2155"/>
                <a:gd name="T4" fmla="*/ 39 w 39"/>
                <a:gd name="T5" fmla="*/ 2155 h 2155"/>
                <a:gd name="T6" fmla="*/ 0 w 39"/>
                <a:gd name="T7" fmla="*/ 2155 h 2155"/>
                <a:gd name="T8" fmla="*/ 0 w 39"/>
                <a:gd name="T9" fmla="*/ 2149 h 2155"/>
                <a:gd name="T10" fmla="*/ 0 w 39"/>
                <a:gd name="T11" fmla="*/ 1719 h 2155"/>
                <a:gd name="T12" fmla="*/ 39 w 39"/>
                <a:gd name="T13" fmla="*/ 1719 h 2155"/>
                <a:gd name="T14" fmla="*/ 39 w 39"/>
                <a:gd name="T15" fmla="*/ 1725 h 2155"/>
                <a:gd name="T16" fmla="*/ 0 w 39"/>
                <a:gd name="T17" fmla="*/ 1725 h 2155"/>
                <a:gd name="T18" fmla="*/ 0 w 39"/>
                <a:gd name="T19" fmla="*/ 1719 h 2155"/>
                <a:gd name="T20" fmla="*/ 0 w 39"/>
                <a:gd name="T21" fmla="*/ 1289 h 2155"/>
                <a:gd name="T22" fmla="*/ 39 w 39"/>
                <a:gd name="T23" fmla="*/ 1289 h 2155"/>
                <a:gd name="T24" fmla="*/ 39 w 39"/>
                <a:gd name="T25" fmla="*/ 1295 h 2155"/>
                <a:gd name="T26" fmla="*/ 0 w 39"/>
                <a:gd name="T27" fmla="*/ 1295 h 2155"/>
                <a:gd name="T28" fmla="*/ 0 w 39"/>
                <a:gd name="T29" fmla="*/ 1289 h 2155"/>
                <a:gd name="T30" fmla="*/ 0 w 39"/>
                <a:gd name="T31" fmla="*/ 859 h 2155"/>
                <a:gd name="T32" fmla="*/ 39 w 39"/>
                <a:gd name="T33" fmla="*/ 859 h 2155"/>
                <a:gd name="T34" fmla="*/ 39 w 39"/>
                <a:gd name="T35" fmla="*/ 865 h 2155"/>
                <a:gd name="T36" fmla="*/ 0 w 39"/>
                <a:gd name="T37" fmla="*/ 865 h 2155"/>
                <a:gd name="T38" fmla="*/ 0 w 39"/>
                <a:gd name="T39" fmla="*/ 859 h 2155"/>
                <a:gd name="T40" fmla="*/ 0 w 39"/>
                <a:gd name="T41" fmla="*/ 429 h 2155"/>
                <a:gd name="T42" fmla="*/ 39 w 39"/>
                <a:gd name="T43" fmla="*/ 429 h 2155"/>
                <a:gd name="T44" fmla="*/ 39 w 39"/>
                <a:gd name="T45" fmla="*/ 435 h 2155"/>
                <a:gd name="T46" fmla="*/ 0 w 39"/>
                <a:gd name="T47" fmla="*/ 435 h 2155"/>
                <a:gd name="T48" fmla="*/ 0 w 39"/>
                <a:gd name="T49" fmla="*/ 429 h 2155"/>
                <a:gd name="T50" fmla="*/ 0 w 39"/>
                <a:gd name="T51" fmla="*/ 0 h 2155"/>
                <a:gd name="T52" fmla="*/ 39 w 39"/>
                <a:gd name="T53" fmla="*/ 0 h 2155"/>
                <a:gd name="T54" fmla="*/ 39 w 39"/>
                <a:gd name="T55" fmla="*/ 6 h 2155"/>
                <a:gd name="T56" fmla="*/ 0 w 39"/>
                <a:gd name="T57" fmla="*/ 6 h 2155"/>
                <a:gd name="T58" fmla="*/ 0 w 39"/>
                <a:gd name="T59" fmla="*/ 0 h 2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39" h="2155">
                  <a:moveTo>
                    <a:pt x="0" y="2149"/>
                  </a:moveTo>
                  <a:lnTo>
                    <a:pt x="39" y="2149"/>
                  </a:lnTo>
                  <a:lnTo>
                    <a:pt x="39" y="2155"/>
                  </a:lnTo>
                  <a:lnTo>
                    <a:pt x="0" y="2155"/>
                  </a:lnTo>
                  <a:lnTo>
                    <a:pt x="0" y="2149"/>
                  </a:lnTo>
                  <a:close/>
                  <a:moveTo>
                    <a:pt x="0" y="1719"/>
                  </a:moveTo>
                  <a:lnTo>
                    <a:pt x="39" y="1719"/>
                  </a:lnTo>
                  <a:lnTo>
                    <a:pt x="39" y="1725"/>
                  </a:lnTo>
                  <a:lnTo>
                    <a:pt x="0" y="1725"/>
                  </a:lnTo>
                  <a:lnTo>
                    <a:pt x="0" y="1719"/>
                  </a:lnTo>
                  <a:close/>
                  <a:moveTo>
                    <a:pt x="0" y="1289"/>
                  </a:moveTo>
                  <a:lnTo>
                    <a:pt x="39" y="1289"/>
                  </a:lnTo>
                  <a:lnTo>
                    <a:pt x="39" y="1295"/>
                  </a:lnTo>
                  <a:lnTo>
                    <a:pt x="0" y="1295"/>
                  </a:lnTo>
                  <a:lnTo>
                    <a:pt x="0" y="1289"/>
                  </a:lnTo>
                  <a:close/>
                  <a:moveTo>
                    <a:pt x="0" y="859"/>
                  </a:moveTo>
                  <a:lnTo>
                    <a:pt x="39" y="859"/>
                  </a:lnTo>
                  <a:lnTo>
                    <a:pt x="39" y="865"/>
                  </a:lnTo>
                  <a:lnTo>
                    <a:pt x="0" y="865"/>
                  </a:lnTo>
                  <a:lnTo>
                    <a:pt x="0" y="859"/>
                  </a:lnTo>
                  <a:close/>
                  <a:moveTo>
                    <a:pt x="0" y="429"/>
                  </a:moveTo>
                  <a:lnTo>
                    <a:pt x="39" y="429"/>
                  </a:lnTo>
                  <a:lnTo>
                    <a:pt x="39" y="435"/>
                  </a:lnTo>
                  <a:lnTo>
                    <a:pt x="0" y="435"/>
                  </a:lnTo>
                  <a:lnTo>
                    <a:pt x="0" y="429"/>
                  </a:lnTo>
                  <a:close/>
                  <a:moveTo>
                    <a:pt x="0" y="0"/>
                  </a:moveTo>
                  <a:lnTo>
                    <a:pt x="39" y="0"/>
                  </a:lnTo>
                  <a:lnTo>
                    <a:pt x="39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Rectangle 12"/>
            <p:cNvSpPr>
              <a:spLocks noChangeArrowheads="1"/>
            </p:cNvSpPr>
            <p:nvPr/>
          </p:nvSpPr>
          <p:spPr bwMode="auto">
            <a:xfrm>
              <a:off x="1138449" y="2543182"/>
              <a:ext cx="7774696" cy="5763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Freeform 13"/>
            <p:cNvSpPr>
              <a:spLocks noEditPoints="1"/>
            </p:cNvSpPr>
            <p:nvPr/>
          </p:nvSpPr>
          <p:spPr bwMode="auto">
            <a:xfrm>
              <a:off x="1136195" y="2546064"/>
              <a:ext cx="7779205" cy="37462"/>
            </a:xfrm>
            <a:custGeom>
              <a:avLst/>
              <a:gdLst>
                <a:gd name="T0" fmla="*/ 0 w 10353"/>
                <a:gd name="T1" fmla="*/ 39 h 39"/>
                <a:gd name="T2" fmla="*/ 362 w 10353"/>
                <a:gd name="T3" fmla="*/ 0 h 39"/>
                <a:gd name="T4" fmla="*/ 357 w 10353"/>
                <a:gd name="T5" fmla="*/ 0 h 39"/>
                <a:gd name="T6" fmla="*/ 719 w 10353"/>
                <a:gd name="T7" fmla="*/ 39 h 39"/>
                <a:gd name="T8" fmla="*/ 719 w 10353"/>
                <a:gd name="T9" fmla="*/ 0 h 39"/>
                <a:gd name="T10" fmla="*/ 1071 w 10353"/>
                <a:gd name="T11" fmla="*/ 39 h 39"/>
                <a:gd name="T12" fmla="*/ 1433 w 10353"/>
                <a:gd name="T13" fmla="*/ 0 h 39"/>
                <a:gd name="T14" fmla="*/ 1427 w 10353"/>
                <a:gd name="T15" fmla="*/ 0 h 39"/>
                <a:gd name="T16" fmla="*/ 1790 w 10353"/>
                <a:gd name="T17" fmla="*/ 39 h 39"/>
                <a:gd name="T18" fmla="*/ 1790 w 10353"/>
                <a:gd name="T19" fmla="*/ 0 h 39"/>
                <a:gd name="T20" fmla="*/ 2141 w 10353"/>
                <a:gd name="T21" fmla="*/ 39 h 39"/>
                <a:gd name="T22" fmla="*/ 2503 w 10353"/>
                <a:gd name="T23" fmla="*/ 0 h 39"/>
                <a:gd name="T24" fmla="*/ 2497 w 10353"/>
                <a:gd name="T25" fmla="*/ 0 h 39"/>
                <a:gd name="T26" fmla="*/ 2860 w 10353"/>
                <a:gd name="T27" fmla="*/ 39 h 39"/>
                <a:gd name="T28" fmla="*/ 2860 w 10353"/>
                <a:gd name="T29" fmla="*/ 0 h 39"/>
                <a:gd name="T30" fmla="*/ 3212 w 10353"/>
                <a:gd name="T31" fmla="*/ 39 h 39"/>
                <a:gd name="T32" fmla="*/ 3574 w 10353"/>
                <a:gd name="T33" fmla="*/ 0 h 39"/>
                <a:gd name="T34" fmla="*/ 3568 w 10353"/>
                <a:gd name="T35" fmla="*/ 0 h 39"/>
                <a:gd name="T36" fmla="*/ 3931 w 10353"/>
                <a:gd name="T37" fmla="*/ 39 h 39"/>
                <a:gd name="T38" fmla="*/ 3931 w 10353"/>
                <a:gd name="T39" fmla="*/ 0 h 39"/>
                <a:gd name="T40" fmla="*/ 4282 w 10353"/>
                <a:gd name="T41" fmla="*/ 39 h 39"/>
                <a:gd name="T42" fmla="*/ 4644 w 10353"/>
                <a:gd name="T43" fmla="*/ 0 h 39"/>
                <a:gd name="T44" fmla="*/ 4638 w 10353"/>
                <a:gd name="T45" fmla="*/ 0 h 39"/>
                <a:gd name="T46" fmla="*/ 5001 w 10353"/>
                <a:gd name="T47" fmla="*/ 39 h 39"/>
                <a:gd name="T48" fmla="*/ 5001 w 10353"/>
                <a:gd name="T49" fmla="*/ 0 h 39"/>
                <a:gd name="T50" fmla="*/ 5352 w 10353"/>
                <a:gd name="T51" fmla="*/ 39 h 39"/>
                <a:gd name="T52" fmla="*/ 5714 w 10353"/>
                <a:gd name="T53" fmla="*/ 0 h 39"/>
                <a:gd name="T54" fmla="*/ 5709 w 10353"/>
                <a:gd name="T55" fmla="*/ 0 h 39"/>
                <a:gd name="T56" fmla="*/ 6071 w 10353"/>
                <a:gd name="T57" fmla="*/ 39 h 39"/>
                <a:gd name="T58" fmla="*/ 6071 w 10353"/>
                <a:gd name="T59" fmla="*/ 0 h 39"/>
                <a:gd name="T60" fmla="*/ 6423 w 10353"/>
                <a:gd name="T61" fmla="*/ 39 h 39"/>
                <a:gd name="T62" fmla="*/ 6785 w 10353"/>
                <a:gd name="T63" fmla="*/ 0 h 39"/>
                <a:gd name="T64" fmla="*/ 6779 w 10353"/>
                <a:gd name="T65" fmla="*/ 0 h 39"/>
                <a:gd name="T66" fmla="*/ 7142 w 10353"/>
                <a:gd name="T67" fmla="*/ 39 h 39"/>
                <a:gd name="T68" fmla="*/ 7142 w 10353"/>
                <a:gd name="T69" fmla="*/ 0 h 39"/>
                <a:gd name="T70" fmla="*/ 7493 w 10353"/>
                <a:gd name="T71" fmla="*/ 39 h 39"/>
                <a:gd name="T72" fmla="*/ 7855 w 10353"/>
                <a:gd name="T73" fmla="*/ 0 h 39"/>
                <a:gd name="T74" fmla="*/ 7849 w 10353"/>
                <a:gd name="T75" fmla="*/ 0 h 39"/>
                <a:gd name="T76" fmla="*/ 8212 w 10353"/>
                <a:gd name="T77" fmla="*/ 39 h 39"/>
                <a:gd name="T78" fmla="*/ 8212 w 10353"/>
                <a:gd name="T79" fmla="*/ 0 h 39"/>
                <a:gd name="T80" fmla="*/ 8564 w 10353"/>
                <a:gd name="T81" fmla="*/ 39 h 39"/>
                <a:gd name="T82" fmla="*/ 8927 w 10353"/>
                <a:gd name="T83" fmla="*/ 0 h 39"/>
                <a:gd name="T84" fmla="*/ 8921 w 10353"/>
                <a:gd name="T85" fmla="*/ 0 h 39"/>
                <a:gd name="T86" fmla="*/ 9283 w 10353"/>
                <a:gd name="T87" fmla="*/ 39 h 39"/>
                <a:gd name="T88" fmla="*/ 9283 w 10353"/>
                <a:gd name="T89" fmla="*/ 0 h 39"/>
                <a:gd name="T90" fmla="*/ 9634 w 10353"/>
                <a:gd name="T91" fmla="*/ 39 h 39"/>
                <a:gd name="T92" fmla="*/ 9997 w 10353"/>
                <a:gd name="T93" fmla="*/ 0 h 39"/>
                <a:gd name="T94" fmla="*/ 9991 w 10353"/>
                <a:gd name="T95" fmla="*/ 0 h 39"/>
                <a:gd name="T96" fmla="*/ 10353 w 10353"/>
                <a:gd name="T97" fmla="*/ 39 h 39"/>
                <a:gd name="T98" fmla="*/ 10353 w 10353"/>
                <a:gd name="T99" fmla="*/ 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10353" h="39">
                  <a:moveTo>
                    <a:pt x="6" y="0"/>
                  </a:moveTo>
                  <a:lnTo>
                    <a:pt x="6" y="39"/>
                  </a:lnTo>
                  <a:lnTo>
                    <a:pt x="0" y="39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362" y="0"/>
                  </a:moveTo>
                  <a:lnTo>
                    <a:pt x="362" y="39"/>
                  </a:lnTo>
                  <a:lnTo>
                    <a:pt x="357" y="39"/>
                  </a:lnTo>
                  <a:lnTo>
                    <a:pt x="357" y="0"/>
                  </a:lnTo>
                  <a:lnTo>
                    <a:pt x="362" y="0"/>
                  </a:lnTo>
                  <a:close/>
                  <a:moveTo>
                    <a:pt x="719" y="0"/>
                  </a:moveTo>
                  <a:lnTo>
                    <a:pt x="719" y="39"/>
                  </a:lnTo>
                  <a:lnTo>
                    <a:pt x="714" y="39"/>
                  </a:lnTo>
                  <a:lnTo>
                    <a:pt x="714" y="0"/>
                  </a:lnTo>
                  <a:lnTo>
                    <a:pt x="719" y="0"/>
                  </a:lnTo>
                  <a:close/>
                  <a:moveTo>
                    <a:pt x="1077" y="0"/>
                  </a:moveTo>
                  <a:lnTo>
                    <a:pt x="1077" y="39"/>
                  </a:lnTo>
                  <a:lnTo>
                    <a:pt x="1071" y="39"/>
                  </a:lnTo>
                  <a:lnTo>
                    <a:pt x="1071" y="0"/>
                  </a:lnTo>
                  <a:lnTo>
                    <a:pt x="1077" y="0"/>
                  </a:lnTo>
                  <a:close/>
                  <a:moveTo>
                    <a:pt x="1433" y="0"/>
                  </a:moveTo>
                  <a:lnTo>
                    <a:pt x="1433" y="39"/>
                  </a:lnTo>
                  <a:lnTo>
                    <a:pt x="1427" y="39"/>
                  </a:lnTo>
                  <a:lnTo>
                    <a:pt x="1427" y="0"/>
                  </a:lnTo>
                  <a:lnTo>
                    <a:pt x="1433" y="0"/>
                  </a:lnTo>
                  <a:close/>
                  <a:moveTo>
                    <a:pt x="1790" y="0"/>
                  </a:moveTo>
                  <a:lnTo>
                    <a:pt x="1790" y="39"/>
                  </a:lnTo>
                  <a:lnTo>
                    <a:pt x="1784" y="39"/>
                  </a:lnTo>
                  <a:lnTo>
                    <a:pt x="1784" y="0"/>
                  </a:lnTo>
                  <a:lnTo>
                    <a:pt x="1790" y="0"/>
                  </a:lnTo>
                  <a:close/>
                  <a:moveTo>
                    <a:pt x="2147" y="0"/>
                  </a:moveTo>
                  <a:lnTo>
                    <a:pt x="2147" y="39"/>
                  </a:lnTo>
                  <a:lnTo>
                    <a:pt x="2141" y="39"/>
                  </a:lnTo>
                  <a:lnTo>
                    <a:pt x="2141" y="0"/>
                  </a:lnTo>
                  <a:lnTo>
                    <a:pt x="2147" y="0"/>
                  </a:lnTo>
                  <a:close/>
                  <a:moveTo>
                    <a:pt x="2503" y="0"/>
                  </a:moveTo>
                  <a:lnTo>
                    <a:pt x="2503" y="39"/>
                  </a:lnTo>
                  <a:lnTo>
                    <a:pt x="2497" y="39"/>
                  </a:lnTo>
                  <a:lnTo>
                    <a:pt x="2497" y="0"/>
                  </a:lnTo>
                  <a:lnTo>
                    <a:pt x="2503" y="0"/>
                  </a:lnTo>
                  <a:close/>
                  <a:moveTo>
                    <a:pt x="2860" y="0"/>
                  </a:moveTo>
                  <a:lnTo>
                    <a:pt x="2860" y="39"/>
                  </a:lnTo>
                  <a:lnTo>
                    <a:pt x="2855" y="39"/>
                  </a:lnTo>
                  <a:lnTo>
                    <a:pt x="2855" y="0"/>
                  </a:lnTo>
                  <a:lnTo>
                    <a:pt x="2860" y="0"/>
                  </a:lnTo>
                  <a:close/>
                  <a:moveTo>
                    <a:pt x="3217" y="0"/>
                  </a:moveTo>
                  <a:lnTo>
                    <a:pt x="3217" y="39"/>
                  </a:lnTo>
                  <a:lnTo>
                    <a:pt x="3212" y="39"/>
                  </a:lnTo>
                  <a:lnTo>
                    <a:pt x="3212" y="0"/>
                  </a:lnTo>
                  <a:lnTo>
                    <a:pt x="3217" y="0"/>
                  </a:lnTo>
                  <a:close/>
                  <a:moveTo>
                    <a:pt x="3574" y="0"/>
                  </a:moveTo>
                  <a:lnTo>
                    <a:pt x="3574" y="39"/>
                  </a:lnTo>
                  <a:lnTo>
                    <a:pt x="3568" y="39"/>
                  </a:lnTo>
                  <a:lnTo>
                    <a:pt x="3568" y="0"/>
                  </a:lnTo>
                  <a:lnTo>
                    <a:pt x="3574" y="0"/>
                  </a:lnTo>
                  <a:close/>
                  <a:moveTo>
                    <a:pt x="3931" y="0"/>
                  </a:moveTo>
                  <a:lnTo>
                    <a:pt x="3931" y="39"/>
                  </a:lnTo>
                  <a:lnTo>
                    <a:pt x="3925" y="39"/>
                  </a:lnTo>
                  <a:lnTo>
                    <a:pt x="3925" y="0"/>
                  </a:lnTo>
                  <a:lnTo>
                    <a:pt x="3931" y="0"/>
                  </a:lnTo>
                  <a:close/>
                  <a:moveTo>
                    <a:pt x="4288" y="0"/>
                  </a:moveTo>
                  <a:lnTo>
                    <a:pt x="4288" y="39"/>
                  </a:lnTo>
                  <a:lnTo>
                    <a:pt x="4282" y="39"/>
                  </a:lnTo>
                  <a:lnTo>
                    <a:pt x="4282" y="0"/>
                  </a:lnTo>
                  <a:lnTo>
                    <a:pt x="4288" y="0"/>
                  </a:lnTo>
                  <a:close/>
                  <a:moveTo>
                    <a:pt x="4644" y="0"/>
                  </a:moveTo>
                  <a:lnTo>
                    <a:pt x="4644" y="39"/>
                  </a:lnTo>
                  <a:lnTo>
                    <a:pt x="4638" y="39"/>
                  </a:lnTo>
                  <a:lnTo>
                    <a:pt x="4638" y="0"/>
                  </a:lnTo>
                  <a:lnTo>
                    <a:pt x="4644" y="0"/>
                  </a:lnTo>
                  <a:close/>
                  <a:moveTo>
                    <a:pt x="5001" y="0"/>
                  </a:moveTo>
                  <a:lnTo>
                    <a:pt x="5001" y="39"/>
                  </a:lnTo>
                  <a:lnTo>
                    <a:pt x="4995" y="39"/>
                  </a:lnTo>
                  <a:lnTo>
                    <a:pt x="4995" y="0"/>
                  </a:lnTo>
                  <a:lnTo>
                    <a:pt x="5001" y="0"/>
                  </a:lnTo>
                  <a:close/>
                  <a:moveTo>
                    <a:pt x="5358" y="0"/>
                  </a:moveTo>
                  <a:lnTo>
                    <a:pt x="5358" y="39"/>
                  </a:lnTo>
                  <a:lnTo>
                    <a:pt x="5352" y="39"/>
                  </a:lnTo>
                  <a:lnTo>
                    <a:pt x="5352" y="0"/>
                  </a:lnTo>
                  <a:lnTo>
                    <a:pt x="5358" y="0"/>
                  </a:lnTo>
                  <a:close/>
                  <a:moveTo>
                    <a:pt x="5714" y="0"/>
                  </a:moveTo>
                  <a:lnTo>
                    <a:pt x="5714" y="39"/>
                  </a:lnTo>
                  <a:lnTo>
                    <a:pt x="5709" y="39"/>
                  </a:lnTo>
                  <a:lnTo>
                    <a:pt x="5709" y="0"/>
                  </a:lnTo>
                  <a:lnTo>
                    <a:pt x="5714" y="0"/>
                  </a:lnTo>
                  <a:close/>
                  <a:moveTo>
                    <a:pt x="6071" y="0"/>
                  </a:moveTo>
                  <a:lnTo>
                    <a:pt x="6071" y="39"/>
                  </a:lnTo>
                  <a:lnTo>
                    <a:pt x="6066" y="39"/>
                  </a:lnTo>
                  <a:lnTo>
                    <a:pt x="6066" y="0"/>
                  </a:lnTo>
                  <a:lnTo>
                    <a:pt x="6071" y="0"/>
                  </a:lnTo>
                  <a:close/>
                  <a:moveTo>
                    <a:pt x="6429" y="0"/>
                  </a:moveTo>
                  <a:lnTo>
                    <a:pt x="6429" y="39"/>
                  </a:lnTo>
                  <a:lnTo>
                    <a:pt x="6423" y="39"/>
                  </a:lnTo>
                  <a:lnTo>
                    <a:pt x="6423" y="0"/>
                  </a:lnTo>
                  <a:lnTo>
                    <a:pt x="6429" y="0"/>
                  </a:lnTo>
                  <a:close/>
                  <a:moveTo>
                    <a:pt x="6785" y="0"/>
                  </a:moveTo>
                  <a:lnTo>
                    <a:pt x="6785" y="39"/>
                  </a:lnTo>
                  <a:lnTo>
                    <a:pt x="6779" y="39"/>
                  </a:lnTo>
                  <a:lnTo>
                    <a:pt x="6779" y="0"/>
                  </a:lnTo>
                  <a:lnTo>
                    <a:pt x="6785" y="0"/>
                  </a:lnTo>
                  <a:close/>
                  <a:moveTo>
                    <a:pt x="7142" y="0"/>
                  </a:moveTo>
                  <a:lnTo>
                    <a:pt x="7142" y="39"/>
                  </a:lnTo>
                  <a:lnTo>
                    <a:pt x="7136" y="39"/>
                  </a:lnTo>
                  <a:lnTo>
                    <a:pt x="7136" y="0"/>
                  </a:lnTo>
                  <a:lnTo>
                    <a:pt x="7142" y="0"/>
                  </a:lnTo>
                  <a:close/>
                  <a:moveTo>
                    <a:pt x="7499" y="0"/>
                  </a:moveTo>
                  <a:lnTo>
                    <a:pt x="7499" y="39"/>
                  </a:lnTo>
                  <a:lnTo>
                    <a:pt x="7493" y="39"/>
                  </a:lnTo>
                  <a:lnTo>
                    <a:pt x="7493" y="0"/>
                  </a:lnTo>
                  <a:lnTo>
                    <a:pt x="7499" y="0"/>
                  </a:lnTo>
                  <a:close/>
                  <a:moveTo>
                    <a:pt x="7855" y="0"/>
                  </a:moveTo>
                  <a:lnTo>
                    <a:pt x="7855" y="39"/>
                  </a:lnTo>
                  <a:lnTo>
                    <a:pt x="7849" y="39"/>
                  </a:lnTo>
                  <a:lnTo>
                    <a:pt x="7849" y="0"/>
                  </a:lnTo>
                  <a:lnTo>
                    <a:pt x="7855" y="0"/>
                  </a:lnTo>
                  <a:close/>
                  <a:moveTo>
                    <a:pt x="8212" y="0"/>
                  </a:moveTo>
                  <a:lnTo>
                    <a:pt x="8212" y="39"/>
                  </a:lnTo>
                  <a:lnTo>
                    <a:pt x="8207" y="39"/>
                  </a:lnTo>
                  <a:lnTo>
                    <a:pt x="8207" y="0"/>
                  </a:lnTo>
                  <a:lnTo>
                    <a:pt x="8212" y="0"/>
                  </a:lnTo>
                  <a:close/>
                  <a:moveTo>
                    <a:pt x="8569" y="0"/>
                  </a:moveTo>
                  <a:lnTo>
                    <a:pt x="8569" y="39"/>
                  </a:lnTo>
                  <a:lnTo>
                    <a:pt x="8564" y="39"/>
                  </a:lnTo>
                  <a:lnTo>
                    <a:pt x="8564" y="0"/>
                  </a:lnTo>
                  <a:lnTo>
                    <a:pt x="8569" y="0"/>
                  </a:lnTo>
                  <a:close/>
                  <a:moveTo>
                    <a:pt x="8927" y="0"/>
                  </a:moveTo>
                  <a:lnTo>
                    <a:pt x="8927" y="39"/>
                  </a:lnTo>
                  <a:lnTo>
                    <a:pt x="8921" y="39"/>
                  </a:lnTo>
                  <a:lnTo>
                    <a:pt x="8921" y="0"/>
                  </a:lnTo>
                  <a:lnTo>
                    <a:pt x="8927" y="0"/>
                  </a:lnTo>
                  <a:close/>
                  <a:moveTo>
                    <a:pt x="9283" y="0"/>
                  </a:moveTo>
                  <a:lnTo>
                    <a:pt x="9283" y="39"/>
                  </a:lnTo>
                  <a:lnTo>
                    <a:pt x="9277" y="39"/>
                  </a:lnTo>
                  <a:lnTo>
                    <a:pt x="9277" y="0"/>
                  </a:lnTo>
                  <a:lnTo>
                    <a:pt x="9283" y="0"/>
                  </a:lnTo>
                  <a:close/>
                  <a:moveTo>
                    <a:pt x="9640" y="0"/>
                  </a:moveTo>
                  <a:lnTo>
                    <a:pt x="9640" y="39"/>
                  </a:lnTo>
                  <a:lnTo>
                    <a:pt x="9634" y="39"/>
                  </a:lnTo>
                  <a:lnTo>
                    <a:pt x="9634" y="0"/>
                  </a:lnTo>
                  <a:lnTo>
                    <a:pt x="9640" y="0"/>
                  </a:lnTo>
                  <a:close/>
                  <a:moveTo>
                    <a:pt x="9997" y="0"/>
                  </a:moveTo>
                  <a:lnTo>
                    <a:pt x="9997" y="39"/>
                  </a:lnTo>
                  <a:lnTo>
                    <a:pt x="9991" y="39"/>
                  </a:lnTo>
                  <a:lnTo>
                    <a:pt x="9991" y="0"/>
                  </a:lnTo>
                  <a:lnTo>
                    <a:pt x="9997" y="0"/>
                  </a:lnTo>
                  <a:close/>
                  <a:moveTo>
                    <a:pt x="10353" y="0"/>
                  </a:moveTo>
                  <a:lnTo>
                    <a:pt x="10353" y="39"/>
                  </a:lnTo>
                  <a:lnTo>
                    <a:pt x="10347" y="39"/>
                  </a:lnTo>
                  <a:lnTo>
                    <a:pt x="10347" y="0"/>
                  </a:lnTo>
                  <a:lnTo>
                    <a:pt x="10353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15"/>
            <p:cNvSpPr>
              <a:spLocks noChangeArrowheads="1"/>
            </p:cNvSpPr>
            <p:nvPr/>
          </p:nvSpPr>
          <p:spPr bwMode="auto">
            <a:xfrm>
              <a:off x="414855" y="2011204"/>
              <a:ext cx="651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,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6"/>
            <p:cNvSpPr>
              <a:spLocks noChangeArrowheads="1"/>
            </p:cNvSpPr>
            <p:nvPr/>
          </p:nvSpPr>
          <p:spPr bwMode="auto">
            <a:xfrm>
              <a:off x="414855" y="1621093"/>
              <a:ext cx="651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,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7"/>
            <p:cNvSpPr>
              <a:spLocks noChangeArrowheads="1"/>
            </p:cNvSpPr>
            <p:nvPr/>
          </p:nvSpPr>
          <p:spPr bwMode="auto">
            <a:xfrm>
              <a:off x="414855" y="1208049"/>
              <a:ext cx="651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3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8"/>
            <p:cNvSpPr>
              <a:spLocks noChangeArrowheads="1"/>
            </p:cNvSpPr>
            <p:nvPr/>
          </p:nvSpPr>
          <p:spPr bwMode="auto">
            <a:xfrm>
              <a:off x="414855" y="795005"/>
              <a:ext cx="651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4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9"/>
            <p:cNvSpPr>
              <a:spLocks noChangeArrowheads="1"/>
            </p:cNvSpPr>
            <p:nvPr/>
          </p:nvSpPr>
          <p:spPr bwMode="auto">
            <a:xfrm>
              <a:off x="414855" y="381000"/>
              <a:ext cx="651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5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0" name="Rectangle 49"/>
            <p:cNvSpPr>
              <a:spLocks noChangeArrowheads="1"/>
            </p:cNvSpPr>
            <p:nvPr/>
          </p:nvSpPr>
          <p:spPr bwMode="auto">
            <a:xfrm>
              <a:off x="6651731" y="609600"/>
              <a:ext cx="103188" cy="10160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1" name="Rectangle 50"/>
            <p:cNvSpPr>
              <a:spLocks noChangeArrowheads="1"/>
            </p:cNvSpPr>
            <p:nvPr/>
          </p:nvSpPr>
          <p:spPr bwMode="auto">
            <a:xfrm>
              <a:off x="6858000" y="533400"/>
              <a:ext cx="18129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Unadsorbed</a:t>
              </a: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erum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53"/>
            <p:cNvSpPr/>
            <p:nvPr/>
          </p:nvSpPr>
          <p:spPr>
            <a:xfrm>
              <a:off x="152400" y="152400"/>
              <a:ext cx="8839200" cy="7239000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3" name="Group 55"/>
            <p:cNvGrpSpPr/>
            <p:nvPr/>
          </p:nvGrpSpPr>
          <p:grpSpPr>
            <a:xfrm>
              <a:off x="1196698" y="3380601"/>
              <a:ext cx="7642502" cy="948859"/>
              <a:chOff x="1372028" y="2482533"/>
              <a:chExt cx="7228618" cy="890074"/>
            </a:xfrm>
          </p:grpSpPr>
          <p:sp>
            <p:nvSpPr>
              <p:cNvPr id="57" name="Rectangle 799"/>
              <p:cNvSpPr>
                <a:spLocks noChangeArrowheads="1"/>
              </p:cNvSpPr>
              <p:nvPr/>
            </p:nvSpPr>
            <p:spPr bwMode="auto">
              <a:xfrm rot="16200000">
                <a:off x="1011492" y="2843181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801"/>
              <p:cNvSpPr>
                <a:spLocks noChangeArrowheads="1"/>
              </p:cNvSpPr>
              <p:nvPr/>
            </p:nvSpPr>
            <p:spPr bwMode="auto">
              <a:xfrm rot="16200000">
                <a:off x="1263907" y="2843183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ctangle 803"/>
              <p:cNvSpPr>
                <a:spLocks noChangeArrowheads="1"/>
              </p:cNvSpPr>
              <p:nvPr/>
            </p:nvSpPr>
            <p:spPr bwMode="auto">
              <a:xfrm rot="16200000">
                <a:off x="1516320" y="28431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805"/>
              <p:cNvSpPr>
                <a:spLocks noChangeArrowheads="1"/>
              </p:cNvSpPr>
              <p:nvPr/>
            </p:nvSpPr>
            <p:spPr bwMode="auto">
              <a:xfrm rot="16200000">
                <a:off x="1770320" y="28431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4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807"/>
              <p:cNvSpPr>
                <a:spLocks noChangeArrowheads="1"/>
              </p:cNvSpPr>
              <p:nvPr/>
            </p:nvSpPr>
            <p:spPr bwMode="auto">
              <a:xfrm rot="16200000">
                <a:off x="2021145" y="2844657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809"/>
              <p:cNvSpPr>
                <a:spLocks noChangeArrowheads="1"/>
              </p:cNvSpPr>
              <p:nvPr/>
            </p:nvSpPr>
            <p:spPr bwMode="auto">
              <a:xfrm rot="16200000">
                <a:off x="2273559" y="2844657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ctangle 811"/>
              <p:cNvSpPr>
                <a:spLocks noChangeArrowheads="1"/>
              </p:cNvSpPr>
              <p:nvPr/>
            </p:nvSpPr>
            <p:spPr bwMode="auto">
              <a:xfrm rot="16200000">
                <a:off x="2525969" y="2844657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813"/>
              <p:cNvSpPr>
                <a:spLocks noChangeArrowheads="1"/>
              </p:cNvSpPr>
              <p:nvPr/>
            </p:nvSpPr>
            <p:spPr bwMode="auto">
              <a:xfrm rot="16200000">
                <a:off x="2778382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ctangle 815"/>
              <p:cNvSpPr>
                <a:spLocks noChangeArrowheads="1"/>
              </p:cNvSpPr>
              <p:nvPr/>
            </p:nvSpPr>
            <p:spPr bwMode="auto">
              <a:xfrm rot="16200000">
                <a:off x="3030795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4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ctangle 817"/>
              <p:cNvSpPr>
                <a:spLocks noChangeArrowheads="1"/>
              </p:cNvSpPr>
              <p:nvPr/>
            </p:nvSpPr>
            <p:spPr bwMode="auto">
              <a:xfrm rot="16200000">
                <a:off x="3281620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819"/>
              <p:cNvSpPr>
                <a:spLocks noChangeArrowheads="1"/>
              </p:cNvSpPr>
              <p:nvPr/>
            </p:nvSpPr>
            <p:spPr bwMode="auto">
              <a:xfrm rot="16200000">
                <a:off x="3534032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ctangle 821"/>
              <p:cNvSpPr>
                <a:spLocks noChangeArrowheads="1"/>
              </p:cNvSpPr>
              <p:nvPr/>
            </p:nvSpPr>
            <p:spPr bwMode="auto">
              <a:xfrm rot="16200000">
                <a:off x="3786446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ctangle 823"/>
              <p:cNvSpPr>
                <a:spLocks noChangeArrowheads="1"/>
              </p:cNvSpPr>
              <p:nvPr/>
            </p:nvSpPr>
            <p:spPr bwMode="auto">
              <a:xfrm rot="16200000">
                <a:off x="4038860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825"/>
              <p:cNvSpPr>
                <a:spLocks noChangeArrowheads="1"/>
              </p:cNvSpPr>
              <p:nvPr/>
            </p:nvSpPr>
            <p:spPr bwMode="auto">
              <a:xfrm rot="16200000">
                <a:off x="4291271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827"/>
              <p:cNvSpPr>
                <a:spLocks noChangeArrowheads="1"/>
              </p:cNvSpPr>
              <p:nvPr/>
            </p:nvSpPr>
            <p:spPr bwMode="auto">
              <a:xfrm rot="16200000">
                <a:off x="4542097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829"/>
              <p:cNvSpPr>
                <a:spLocks noChangeArrowheads="1"/>
              </p:cNvSpPr>
              <p:nvPr/>
            </p:nvSpPr>
            <p:spPr bwMode="auto">
              <a:xfrm rot="16200000">
                <a:off x="4794509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3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ctangle 831"/>
              <p:cNvSpPr>
                <a:spLocks noChangeArrowheads="1"/>
              </p:cNvSpPr>
              <p:nvPr/>
            </p:nvSpPr>
            <p:spPr bwMode="auto">
              <a:xfrm rot="16200000">
                <a:off x="5046922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Rectangle 833"/>
              <p:cNvSpPr>
                <a:spLocks noChangeArrowheads="1"/>
              </p:cNvSpPr>
              <p:nvPr/>
            </p:nvSpPr>
            <p:spPr bwMode="auto">
              <a:xfrm rot="16200000">
                <a:off x="5297745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Rectangle 835"/>
              <p:cNvSpPr>
                <a:spLocks noChangeArrowheads="1"/>
              </p:cNvSpPr>
              <p:nvPr/>
            </p:nvSpPr>
            <p:spPr bwMode="auto">
              <a:xfrm rot="16200000">
                <a:off x="5551745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837"/>
              <p:cNvSpPr>
                <a:spLocks noChangeArrowheads="1"/>
              </p:cNvSpPr>
              <p:nvPr/>
            </p:nvSpPr>
            <p:spPr bwMode="auto">
              <a:xfrm rot="16200000">
                <a:off x="5802571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839"/>
              <p:cNvSpPr>
                <a:spLocks noChangeArrowheads="1"/>
              </p:cNvSpPr>
              <p:nvPr/>
            </p:nvSpPr>
            <p:spPr bwMode="auto">
              <a:xfrm rot="16200000">
                <a:off x="6054984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5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841"/>
              <p:cNvSpPr>
                <a:spLocks noChangeArrowheads="1"/>
              </p:cNvSpPr>
              <p:nvPr/>
            </p:nvSpPr>
            <p:spPr bwMode="auto">
              <a:xfrm rot="16200000">
                <a:off x="6307397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6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ctangle 843"/>
              <p:cNvSpPr>
                <a:spLocks noChangeArrowheads="1"/>
              </p:cNvSpPr>
              <p:nvPr/>
            </p:nvSpPr>
            <p:spPr bwMode="auto">
              <a:xfrm rot="16200000">
                <a:off x="6559809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845"/>
              <p:cNvSpPr>
                <a:spLocks noChangeArrowheads="1"/>
              </p:cNvSpPr>
              <p:nvPr/>
            </p:nvSpPr>
            <p:spPr bwMode="auto">
              <a:xfrm rot="16200000">
                <a:off x="6812221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847"/>
              <p:cNvSpPr>
                <a:spLocks noChangeArrowheads="1"/>
              </p:cNvSpPr>
              <p:nvPr/>
            </p:nvSpPr>
            <p:spPr bwMode="auto">
              <a:xfrm rot="16200000">
                <a:off x="7063045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ctangle 849"/>
              <p:cNvSpPr>
                <a:spLocks noChangeArrowheads="1"/>
              </p:cNvSpPr>
              <p:nvPr/>
            </p:nvSpPr>
            <p:spPr bwMode="auto">
              <a:xfrm rot="16200000">
                <a:off x="7315459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Rectangle 851"/>
              <p:cNvSpPr>
                <a:spLocks noChangeArrowheads="1"/>
              </p:cNvSpPr>
              <p:nvPr/>
            </p:nvSpPr>
            <p:spPr bwMode="auto">
              <a:xfrm rot="16200000">
                <a:off x="7567869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Rectangle 853"/>
              <p:cNvSpPr>
                <a:spLocks noChangeArrowheads="1"/>
              </p:cNvSpPr>
              <p:nvPr/>
            </p:nvSpPr>
            <p:spPr bwMode="auto">
              <a:xfrm rot="16200000">
                <a:off x="7820284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ctangle 855"/>
              <p:cNvSpPr>
                <a:spLocks noChangeArrowheads="1"/>
              </p:cNvSpPr>
              <p:nvPr/>
            </p:nvSpPr>
            <p:spPr bwMode="auto">
              <a:xfrm rot="16200000">
                <a:off x="8072696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" name="Group 85"/>
            <p:cNvGrpSpPr/>
            <p:nvPr/>
          </p:nvGrpSpPr>
          <p:grpSpPr>
            <a:xfrm>
              <a:off x="1188185" y="2618599"/>
              <a:ext cx="7633099" cy="869071"/>
              <a:chOff x="1497921" y="3022691"/>
              <a:chExt cx="7219723" cy="689319"/>
            </a:xfrm>
          </p:grpSpPr>
          <p:sp>
            <p:nvSpPr>
              <p:cNvPr id="87" name="Rectangle 800"/>
              <p:cNvSpPr>
                <a:spLocks noChangeArrowheads="1"/>
              </p:cNvSpPr>
              <p:nvPr/>
            </p:nvSpPr>
            <p:spPr bwMode="auto">
              <a:xfrm rot="16200000">
                <a:off x="1257571" y="3306102"/>
                <a:ext cx="640810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1</a:t>
                </a:r>
              </a:p>
            </p:txBody>
          </p:sp>
          <p:sp>
            <p:nvSpPr>
              <p:cNvPr id="88" name="Rectangle 802"/>
              <p:cNvSpPr>
                <a:spLocks noChangeArrowheads="1"/>
              </p:cNvSpPr>
              <p:nvPr/>
            </p:nvSpPr>
            <p:spPr bwMode="auto">
              <a:xfrm rot="16200000">
                <a:off x="1509983" y="3306101"/>
                <a:ext cx="640810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2</a:t>
                </a:r>
              </a:p>
            </p:txBody>
          </p:sp>
          <p:sp>
            <p:nvSpPr>
              <p:cNvPr id="89" name="Rectangle 804"/>
              <p:cNvSpPr>
                <a:spLocks noChangeArrowheads="1"/>
              </p:cNvSpPr>
              <p:nvPr/>
            </p:nvSpPr>
            <p:spPr bwMode="auto">
              <a:xfrm rot="16200000">
                <a:off x="1762397" y="3306101"/>
                <a:ext cx="640810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1</a:t>
                </a:r>
              </a:p>
            </p:txBody>
          </p:sp>
          <p:sp>
            <p:nvSpPr>
              <p:cNvPr id="90" name="Rectangle 806"/>
              <p:cNvSpPr>
                <a:spLocks noChangeArrowheads="1"/>
              </p:cNvSpPr>
              <p:nvPr/>
            </p:nvSpPr>
            <p:spPr bwMode="auto">
              <a:xfrm rot="16200000">
                <a:off x="2014807" y="3306101"/>
                <a:ext cx="640810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1</a:t>
                </a:r>
              </a:p>
            </p:txBody>
          </p:sp>
          <p:sp>
            <p:nvSpPr>
              <p:cNvPr id="91" name="Rectangle 808"/>
              <p:cNvSpPr>
                <a:spLocks noChangeArrowheads="1"/>
              </p:cNvSpPr>
              <p:nvPr/>
            </p:nvSpPr>
            <p:spPr bwMode="auto">
              <a:xfrm rot="16200000">
                <a:off x="2267221" y="3306101"/>
                <a:ext cx="640810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1</a:t>
                </a:r>
              </a:p>
            </p:txBody>
          </p:sp>
          <p:sp>
            <p:nvSpPr>
              <p:cNvPr id="92" name="Rectangle 810"/>
              <p:cNvSpPr>
                <a:spLocks noChangeArrowheads="1"/>
              </p:cNvSpPr>
              <p:nvPr/>
            </p:nvSpPr>
            <p:spPr bwMode="auto">
              <a:xfrm rot="16200000">
                <a:off x="2525988" y="3306104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1</a:t>
                </a:r>
              </a:p>
            </p:txBody>
          </p:sp>
          <p:sp>
            <p:nvSpPr>
              <p:cNvPr id="93" name="Rectangle 812"/>
              <p:cNvSpPr>
                <a:spLocks noChangeArrowheads="1"/>
              </p:cNvSpPr>
              <p:nvPr/>
            </p:nvSpPr>
            <p:spPr bwMode="auto">
              <a:xfrm rot="16200000">
                <a:off x="2778404" y="3304519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2</a:t>
                </a:r>
              </a:p>
            </p:txBody>
          </p:sp>
          <p:sp>
            <p:nvSpPr>
              <p:cNvPr id="94" name="Rectangle 814"/>
              <p:cNvSpPr>
                <a:spLocks noChangeArrowheads="1"/>
              </p:cNvSpPr>
              <p:nvPr/>
            </p:nvSpPr>
            <p:spPr bwMode="auto">
              <a:xfrm rot="16200000">
                <a:off x="3029229" y="3304519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1</a:t>
                </a:r>
              </a:p>
            </p:txBody>
          </p:sp>
          <p:sp>
            <p:nvSpPr>
              <p:cNvPr id="95" name="Rectangle 816"/>
              <p:cNvSpPr>
                <a:spLocks noChangeArrowheads="1"/>
              </p:cNvSpPr>
              <p:nvPr/>
            </p:nvSpPr>
            <p:spPr bwMode="auto">
              <a:xfrm rot="16200000">
                <a:off x="3281642" y="3304519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2</a:t>
                </a:r>
              </a:p>
            </p:txBody>
          </p:sp>
          <p:sp>
            <p:nvSpPr>
              <p:cNvPr id="96" name="Rectangle 818"/>
              <p:cNvSpPr>
                <a:spLocks noChangeArrowheads="1"/>
              </p:cNvSpPr>
              <p:nvPr/>
            </p:nvSpPr>
            <p:spPr bwMode="auto">
              <a:xfrm rot="16200000">
                <a:off x="3527697" y="3311550"/>
                <a:ext cx="640810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5:01</a:t>
                </a:r>
              </a:p>
            </p:txBody>
          </p:sp>
          <p:sp>
            <p:nvSpPr>
              <p:cNvPr id="97" name="Rectangle 820"/>
              <p:cNvSpPr>
                <a:spLocks noChangeArrowheads="1"/>
              </p:cNvSpPr>
              <p:nvPr/>
            </p:nvSpPr>
            <p:spPr bwMode="auto">
              <a:xfrm rot="16200000">
                <a:off x="3786465" y="3299249"/>
                <a:ext cx="628095" cy="1601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5:02</a:t>
                </a:r>
              </a:p>
            </p:txBody>
          </p:sp>
          <p:sp>
            <p:nvSpPr>
              <p:cNvPr id="98" name="Rectangle 822"/>
              <p:cNvSpPr>
                <a:spLocks noChangeArrowheads="1"/>
              </p:cNvSpPr>
              <p:nvPr/>
            </p:nvSpPr>
            <p:spPr bwMode="auto">
              <a:xfrm rot="16200000">
                <a:off x="4038880" y="3305006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2</a:t>
                </a:r>
              </a:p>
            </p:txBody>
          </p:sp>
          <p:sp>
            <p:nvSpPr>
              <p:cNvPr id="99" name="Rectangle 824"/>
              <p:cNvSpPr>
                <a:spLocks noChangeArrowheads="1"/>
              </p:cNvSpPr>
              <p:nvPr/>
            </p:nvSpPr>
            <p:spPr bwMode="auto">
              <a:xfrm rot="16200000">
                <a:off x="4289705" y="3305006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2</a:t>
                </a:r>
              </a:p>
            </p:txBody>
          </p:sp>
          <p:sp>
            <p:nvSpPr>
              <p:cNvPr id="100" name="Rectangle 826"/>
              <p:cNvSpPr>
                <a:spLocks noChangeArrowheads="1"/>
              </p:cNvSpPr>
              <p:nvPr/>
            </p:nvSpPr>
            <p:spPr bwMode="auto">
              <a:xfrm rot="16200000">
                <a:off x="4542118" y="3305006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4</a:t>
                </a:r>
              </a:p>
            </p:txBody>
          </p:sp>
          <p:sp>
            <p:nvSpPr>
              <p:cNvPr id="101" name="Rectangle 828"/>
              <p:cNvSpPr>
                <a:spLocks noChangeArrowheads="1"/>
              </p:cNvSpPr>
              <p:nvPr/>
            </p:nvSpPr>
            <p:spPr bwMode="auto">
              <a:xfrm rot="16200000">
                <a:off x="4794530" y="3305006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9</a:t>
                </a:r>
              </a:p>
            </p:txBody>
          </p:sp>
          <p:sp>
            <p:nvSpPr>
              <p:cNvPr id="102" name="Rectangle 830"/>
              <p:cNvSpPr>
                <a:spLocks noChangeArrowheads="1"/>
              </p:cNvSpPr>
              <p:nvPr/>
            </p:nvSpPr>
            <p:spPr bwMode="auto">
              <a:xfrm rot="16200000">
                <a:off x="5046943" y="3305006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1</a:t>
                </a:r>
              </a:p>
            </p:txBody>
          </p:sp>
          <p:sp>
            <p:nvSpPr>
              <p:cNvPr id="103" name="Rectangle 832"/>
              <p:cNvSpPr>
                <a:spLocks noChangeArrowheads="1"/>
              </p:cNvSpPr>
              <p:nvPr/>
            </p:nvSpPr>
            <p:spPr bwMode="auto">
              <a:xfrm rot="16200000">
                <a:off x="5299352" y="3305006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3</a:t>
                </a:r>
              </a:p>
            </p:txBody>
          </p:sp>
          <p:sp>
            <p:nvSpPr>
              <p:cNvPr id="104" name="Rectangle 834"/>
              <p:cNvSpPr>
                <a:spLocks noChangeArrowheads="1"/>
              </p:cNvSpPr>
              <p:nvPr/>
            </p:nvSpPr>
            <p:spPr bwMode="auto">
              <a:xfrm rot="16200000">
                <a:off x="5525830" y="3278929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05" name="Rectangle 836"/>
              <p:cNvSpPr>
                <a:spLocks noChangeArrowheads="1"/>
              </p:cNvSpPr>
              <p:nvPr/>
            </p:nvSpPr>
            <p:spPr bwMode="auto">
              <a:xfrm rot="16200000">
                <a:off x="5779830" y="3278929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06" name="Rectangle 838"/>
              <p:cNvSpPr>
                <a:spLocks noChangeArrowheads="1"/>
              </p:cNvSpPr>
              <p:nvPr/>
            </p:nvSpPr>
            <p:spPr bwMode="auto">
              <a:xfrm rot="16200000">
                <a:off x="6032245" y="3278929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07" name="Rectangle 840"/>
              <p:cNvSpPr>
                <a:spLocks noChangeArrowheads="1"/>
              </p:cNvSpPr>
              <p:nvPr/>
            </p:nvSpPr>
            <p:spPr bwMode="auto">
              <a:xfrm rot="16200000">
                <a:off x="6284656" y="3278929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08" name="Rectangle 842"/>
              <p:cNvSpPr>
                <a:spLocks noChangeArrowheads="1"/>
              </p:cNvSpPr>
              <p:nvPr/>
            </p:nvSpPr>
            <p:spPr bwMode="auto">
              <a:xfrm rot="16200000">
                <a:off x="6537070" y="3278929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09" name="Rectangle 844"/>
              <p:cNvSpPr>
                <a:spLocks noChangeArrowheads="1"/>
              </p:cNvSpPr>
              <p:nvPr/>
            </p:nvSpPr>
            <p:spPr bwMode="auto">
              <a:xfrm rot="16200000">
                <a:off x="6810656" y="3317122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110" name="Rectangle 846"/>
              <p:cNvSpPr>
                <a:spLocks noChangeArrowheads="1"/>
              </p:cNvSpPr>
              <p:nvPr/>
            </p:nvSpPr>
            <p:spPr bwMode="auto">
              <a:xfrm rot="16200000">
                <a:off x="7063065" y="3317122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111" name="Rectangle 848"/>
              <p:cNvSpPr>
                <a:spLocks noChangeArrowheads="1"/>
              </p:cNvSpPr>
              <p:nvPr/>
            </p:nvSpPr>
            <p:spPr bwMode="auto">
              <a:xfrm rot="16200000">
                <a:off x="7315478" y="3317122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112" name="Rectangle 850"/>
              <p:cNvSpPr>
                <a:spLocks noChangeArrowheads="1"/>
              </p:cNvSpPr>
              <p:nvPr/>
            </p:nvSpPr>
            <p:spPr bwMode="auto">
              <a:xfrm rot="16200000">
                <a:off x="7567890" y="3317122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113" name="Rectangle 852"/>
              <p:cNvSpPr>
                <a:spLocks noChangeArrowheads="1"/>
              </p:cNvSpPr>
              <p:nvPr/>
            </p:nvSpPr>
            <p:spPr bwMode="auto">
              <a:xfrm rot="16200000">
                <a:off x="7820305" y="3317122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3</a:t>
                </a:r>
              </a:p>
            </p:txBody>
          </p:sp>
          <p:sp>
            <p:nvSpPr>
              <p:cNvPr id="114" name="Rectangle 854"/>
              <p:cNvSpPr>
                <a:spLocks noChangeArrowheads="1"/>
              </p:cNvSpPr>
              <p:nvPr/>
            </p:nvSpPr>
            <p:spPr bwMode="auto">
              <a:xfrm rot="16200000">
                <a:off x="8071129" y="3317122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3</a:t>
                </a:r>
              </a:p>
            </p:txBody>
          </p:sp>
          <p:sp>
            <p:nvSpPr>
              <p:cNvPr id="115" name="Rectangle 856"/>
              <p:cNvSpPr>
                <a:spLocks noChangeArrowheads="1"/>
              </p:cNvSpPr>
              <p:nvPr/>
            </p:nvSpPr>
            <p:spPr bwMode="auto">
              <a:xfrm rot="16200000">
                <a:off x="8323541" y="3300976"/>
                <a:ext cx="628095" cy="16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3</a:t>
                </a:r>
              </a:p>
            </p:txBody>
          </p:sp>
        </p:grpSp>
        <p:sp>
          <p:nvSpPr>
            <p:cNvPr id="116" name="TextBox 115"/>
            <p:cNvSpPr txBox="1"/>
            <p:nvPr/>
          </p:nvSpPr>
          <p:spPr>
            <a:xfrm>
              <a:off x="553639" y="2771780"/>
              <a:ext cx="575248" cy="640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Beta</a:t>
              </a:r>
            </a:p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a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527988" y="3535602"/>
              <a:ext cx="602066" cy="640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lpha</a:t>
              </a:r>
            </a:p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a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Rectangle 190"/>
            <p:cNvSpPr>
              <a:spLocks noChangeArrowheads="1"/>
            </p:cNvSpPr>
            <p:nvPr/>
          </p:nvSpPr>
          <p:spPr bwMode="auto">
            <a:xfrm>
              <a:off x="2451318" y="152400"/>
              <a:ext cx="45969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DQB </a:t>
              </a:r>
              <a:r>
                <a:rPr kumimoji="0" lang="en-US" sz="1600" b="0" i="0" u="none" strike="noStrike" cap="none" normalizeH="0" baseline="0" dirty="0" err="1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epitope</a:t>
              </a: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exclusive to  DQB1*05:01 chain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3367751" y="4295001"/>
              <a:ext cx="31092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HLA DQ Single Antigen beads specificitie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1" name="Straight Connector 120"/>
            <p:cNvCxnSpPr/>
            <p:nvPr/>
          </p:nvCxnSpPr>
          <p:spPr>
            <a:xfrm>
              <a:off x="152400" y="4549226"/>
              <a:ext cx="8839200" cy="75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76" name="Picture 5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400" y="4648200"/>
              <a:ext cx="5181599" cy="2590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" name="Group 121"/>
            <p:cNvGrpSpPr/>
            <p:nvPr/>
          </p:nvGrpSpPr>
          <p:grpSpPr>
            <a:xfrm>
              <a:off x="5867400" y="4686300"/>
              <a:ext cx="2590800" cy="2552700"/>
              <a:chOff x="6972262" y="4686300"/>
              <a:chExt cx="1764382" cy="1959730"/>
            </a:xfrm>
          </p:grpSpPr>
          <p:pic>
            <p:nvPicPr>
              <p:cNvPr id="1049" name="Picture 1048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28643" t="23791" r="36674" b="4877"/>
              <a:stretch/>
            </p:blipFill>
            <p:spPr>
              <a:xfrm>
                <a:off x="6972827" y="4686300"/>
                <a:ext cx="1763817" cy="195973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29" name="TextBox 128"/>
              <p:cNvSpPr txBox="1"/>
              <p:nvPr/>
            </p:nvSpPr>
            <p:spPr>
              <a:xfrm>
                <a:off x="6972262" y="4723870"/>
                <a:ext cx="70418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Peptide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7727971" y="4903051"/>
                <a:ext cx="352829" cy="30716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Beta</a:t>
                </a:r>
              </a:p>
              <a:p>
                <a:pPr algn="ctr"/>
                <a:r>
                  <a:rPr lang="en-US" sz="10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hain</a:t>
                </a:r>
                <a:endParaRPr lang="en-US" sz="10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7802559" y="5359043"/>
                <a:ext cx="497202" cy="30716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Alpha</a:t>
                </a:r>
              </a:p>
              <a:p>
                <a:pPr algn="ctr"/>
                <a:r>
                  <a:rPr lang="en-US" sz="10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hain</a:t>
                </a:r>
                <a:endParaRPr lang="en-US" sz="10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7698772" y="5885538"/>
                <a:ext cx="369204" cy="2126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125S</a:t>
                </a:r>
                <a:endParaRPr lang="en-US" sz="12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7387659" y="5454446"/>
                <a:ext cx="381213" cy="2126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126Q</a:t>
                </a:r>
                <a:endParaRPr lang="en-US" sz="12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053" name="Straight Arrow Connector 1052"/>
              <p:cNvCxnSpPr>
                <a:stCxn id="133" idx="0"/>
              </p:cNvCxnSpPr>
              <p:nvPr/>
            </p:nvCxnSpPr>
            <p:spPr>
              <a:xfrm flipH="1" flipV="1">
                <a:off x="7854453" y="5768539"/>
                <a:ext cx="28921" cy="11699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Straight Arrow Connector 138"/>
              <p:cNvCxnSpPr/>
              <p:nvPr/>
            </p:nvCxnSpPr>
            <p:spPr>
              <a:xfrm>
                <a:off x="7594985" y="5651540"/>
                <a:ext cx="88213" cy="4933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6" name="TextBox 145"/>
              <p:cNvSpPr txBox="1"/>
              <p:nvPr/>
            </p:nvSpPr>
            <p:spPr>
              <a:xfrm>
                <a:off x="7636372" y="6049167"/>
                <a:ext cx="489238" cy="4001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Beta</a:t>
                </a:r>
              </a:p>
              <a:p>
                <a:pPr algn="ctr"/>
                <a:r>
                  <a:rPr lang="en-US" sz="10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hain</a:t>
                </a:r>
                <a:endParaRPr lang="en-US" sz="10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47" name="Straight Arrow Connector 146"/>
              <p:cNvCxnSpPr>
                <a:stCxn id="129" idx="2"/>
              </p:cNvCxnSpPr>
              <p:nvPr/>
            </p:nvCxnSpPr>
            <p:spPr>
              <a:xfrm>
                <a:off x="7324353" y="4954702"/>
                <a:ext cx="142196" cy="14970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3" name="TextBox 122"/>
            <p:cNvSpPr txBox="1"/>
            <p:nvPr/>
          </p:nvSpPr>
          <p:spPr>
            <a:xfrm rot="16200000">
              <a:off x="-922345" y="1593173"/>
              <a:ext cx="24513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Fluorescence Intensity (MFI)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0" y="74711"/>
            <a:ext cx="853791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Figure M. 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2022 exclusive to DQB1*05:01 chain on the DQ5 antigen and defined by 125S+126Q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170269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19</Words>
  <Application>Microsoft Office PowerPoint</Application>
  <PresentationFormat>On-screen Show (4:3)</PresentationFormat>
  <Paragraphs>8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1</cp:revision>
  <dcterms:created xsi:type="dcterms:W3CDTF">2017-03-12T04:33:29Z</dcterms:created>
  <dcterms:modified xsi:type="dcterms:W3CDTF">2017-03-12T04:37:36Z</dcterms:modified>
</cp:coreProperties>
</file>